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82" r:id="rId3"/>
    <p:sldId id="289" r:id="rId4"/>
    <p:sldId id="281" r:id="rId5"/>
    <p:sldId id="283" r:id="rId6"/>
    <p:sldId id="285" r:id="rId7"/>
    <p:sldId id="284" r:id="rId8"/>
    <p:sldId id="288" r:id="rId9"/>
    <p:sldId id="267" r:id="rId10"/>
    <p:sldId id="268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60" d="100"/>
          <a:sy n="160" d="100"/>
        </p:scale>
        <p:origin x="2586" y="30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upplementary figures</a:t>
            </a:r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132540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395" y="721360"/>
            <a:ext cx="8579210" cy="5415279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="" xmlns:a16="http://schemas.microsoft.com/office/drawing/2014/main" id="{6405A716-C1A6-7849-80C0-346E6C40FDF7}"/>
              </a:ext>
            </a:extLst>
          </p:cNvPr>
          <p:cNvSpPr/>
          <p:nvPr/>
        </p:nvSpPr>
        <p:spPr>
          <a:xfrm>
            <a:off x="0" y="30081"/>
            <a:ext cx="108012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Figure </a:t>
            </a:r>
            <a:r>
              <a:rPr lang="en-GB" b="1" dirty="0" smtClean="0"/>
              <a:t>S9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7670816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856" b="26965"/>
          <a:stretch/>
        </p:blipFill>
        <p:spPr bwMode="auto">
          <a:xfrm>
            <a:off x="4572000" y="1904999"/>
            <a:ext cx="4724400" cy="48861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4840916" y="1066800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 Black" pitchFamily="34" charset="0"/>
              </a:rPr>
              <a:t>WTAP</a:t>
            </a:r>
            <a:endParaRPr lang="en-GB" dirty="0">
              <a:latin typeface="Arial Black" pitchFamily="34" charset="0"/>
            </a:endParaRPr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622" b="25643"/>
          <a:stretch/>
        </p:blipFill>
        <p:spPr bwMode="auto">
          <a:xfrm>
            <a:off x="2216" y="1905000"/>
            <a:ext cx="4645983" cy="49496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81000" y="1066800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 Black" pitchFamily="34" charset="0"/>
              </a:rPr>
              <a:t>METTL14</a:t>
            </a:r>
            <a:endParaRPr lang="en-GB" dirty="0">
              <a:latin typeface="Arial Black" pitchFamily="34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D0AA03BA-EE0D-1A42-9A43-599862D81591}"/>
              </a:ext>
            </a:extLst>
          </p:cNvPr>
          <p:cNvSpPr/>
          <p:nvPr/>
        </p:nvSpPr>
        <p:spPr>
          <a:xfrm>
            <a:off x="0" y="30081"/>
            <a:ext cx="108012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Figure </a:t>
            </a:r>
            <a:r>
              <a:rPr lang="en-GB" b="1" dirty="0" smtClean="0"/>
              <a:t>S1 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457200" y="609600"/>
            <a:ext cx="5334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 Black" pitchFamily="34" charset="0"/>
              </a:rPr>
              <a:t>A</a:t>
            </a:r>
            <a:endParaRPr lang="en-GB" dirty="0">
              <a:latin typeface="Arial Black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800600" y="609600"/>
            <a:ext cx="5334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 Black" pitchFamily="34" charset="0"/>
              </a:rPr>
              <a:t>B</a:t>
            </a:r>
            <a:endParaRPr lang="en-GB" dirty="0"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73151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D0AA03BA-EE0D-1A42-9A43-599862D81591}"/>
              </a:ext>
            </a:extLst>
          </p:cNvPr>
          <p:cNvSpPr/>
          <p:nvPr/>
        </p:nvSpPr>
        <p:spPr>
          <a:xfrm>
            <a:off x="0" y="30081"/>
            <a:ext cx="108012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Figure </a:t>
            </a:r>
            <a:r>
              <a:rPr lang="en-GB" b="1" dirty="0" smtClean="0"/>
              <a:t>S2 </a:t>
            </a:r>
            <a:endParaRPr lang="en-US" b="1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5482" y="30081"/>
            <a:ext cx="4278518" cy="68279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5257800" y="1383268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 Black" pitchFamily="34" charset="0"/>
              </a:rPr>
              <a:t>WTAP</a:t>
            </a:r>
            <a:endParaRPr lang="en-GB" dirty="0">
              <a:latin typeface="Arial Black" pitchFamily="34" charset="0"/>
            </a:endParaRPr>
          </a:p>
        </p:txBody>
      </p:sp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1" y="30081"/>
            <a:ext cx="4560682" cy="68279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838200" y="1383268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 Black" pitchFamily="34" charset="0"/>
              </a:rPr>
              <a:t>METTL14</a:t>
            </a:r>
            <a:endParaRPr lang="en-GB" dirty="0">
              <a:latin typeface="Arial Black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838200" y="609600"/>
            <a:ext cx="5334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 Black" pitchFamily="34" charset="0"/>
              </a:rPr>
              <a:t>A</a:t>
            </a:r>
            <a:endParaRPr lang="en-GB" dirty="0">
              <a:latin typeface="Arial Black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257800" y="609600"/>
            <a:ext cx="5334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 Black" pitchFamily="34" charset="0"/>
              </a:rPr>
              <a:t>B</a:t>
            </a:r>
            <a:endParaRPr lang="en-GB" dirty="0"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59978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971600" y="55069"/>
            <a:ext cx="7880095" cy="6747862"/>
            <a:chOff x="269650" y="194846"/>
            <a:chExt cx="8582045" cy="734895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302" y="304800"/>
              <a:ext cx="8559393" cy="365760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302" y="3886200"/>
              <a:ext cx="8559393" cy="3657600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269650" y="194846"/>
              <a:ext cx="4161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b="1" dirty="0">
                  <a:latin typeface="Arial" pitchFamily="34" charset="0"/>
                  <a:cs typeface="Arial" pitchFamily="34" charset="0"/>
                </a:rPr>
                <a:t>A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69650" y="3776246"/>
              <a:ext cx="4161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b="1" dirty="0">
                  <a:latin typeface="Arial" pitchFamily="34" charset="0"/>
                  <a:cs typeface="Arial" pitchFamily="34" charset="0"/>
                </a:rPr>
                <a:t>B</a:t>
              </a:r>
            </a:p>
          </p:txBody>
        </p:sp>
      </p:grpSp>
      <p:sp>
        <p:nvSpPr>
          <p:cNvPr id="7" name="Rectangle 6">
            <a:extLst>
              <a:ext uri="{FF2B5EF4-FFF2-40B4-BE49-F238E27FC236}">
                <a16:creationId xmlns:a16="http://schemas.microsoft.com/office/drawing/2014/main" xmlns="" id="{D0AA03BA-EE0D-1A42-9A43-599862D81591}"/>
              </a:ext>
            </a:extLst>
          </p:cNvPr>
          <p:cNvSpPr/>
          <p:nvPr/>
        </p:nvSpPr>
        <p:spPr>
          <a:xfrm>
            <a:off x="0" y="30081"/>
            <a:ext cx="108012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Figure </a:t>
            </a:r>
            <a:r>
              <a:rPr lang="en-GB" b="1" dirty="0" smtClean="0"/>
              <a:t>S3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5686938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170" b="25382"/>
          <a:stretch/>
        </p:blipFill>
        <p:spPr bwMode="auto">
          <a:xfrm>
            <a:off x="0" y="1961147"/>
            <a:ext cx="4876800" cy="48968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0" y="1295400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 Black" pitchFamily="34" charset="0"/>
              </a:rPr>
              <a:t>YTHDF1</a:t>
            </a:r>
            <a:endParaRPr lang="en-GB" dirty="0">
              <a:latin typeface="Arial Black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876800" y="1307068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 Black" pitchFamily="34" charset="0"/>
              </a:rPr>
              <a:t>YTHDF2</a:t>
            </a:r>
            <a:endParaRPr lang="en-GB" dirty="0">
              <a:latin typeface="Arial Black" pitchFamily="34" charset="0"/>
            </a:endParaRPr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870" b="26080"/>
          <a:stretch/>
        </p:blipFill>
        <p:spPr bwMode="auto">
          <a:xfrm>
            <a:off x="4876800" y="1961147"/>
            <a:ext cx="4495800" cy="48968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D0AA03BA-EE0D-1A42-9A43-599862D81591}"/>
              </a:ext>
            </a:extLst>
          </p:cNvPr>
          <p:cNvSpPr/>
          <p:nvPr/>
        </p:nvSpPr>
        <p:spPr>
          <a:xfrm>
            <a:off x="0" y="30081"/>
            <a:ext cx="108012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Figure </a:t>
            </a:r>
            <a:r>
              <a:rPr lang="en-GB" b="1" dirty="0" smtClean="0"/>
              <a:t>S4 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0" y="609600"/>
            <a:ext cx="5334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 Black" pitchFamily="34" charset="0"/>
              </a:rPr>
              <a:t>A</a:t>
            </a:r>
            <a:endParaRPr lang="en-GB" dirty="0">
              <a:latin typeface="Arial Black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876800" y="609600"/>
            <a:ext cx="5334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 Black" pitchFamily="34" charset="0"/>
              </a:rPr>
              <a:t>B</a:t>
            </a:r>
            <a:endParaRPr lang="en-GB" dirty="0"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65231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525" b="26351"/>
          <a:stretch/>
        </p:blipFill>
        <p:spPr bwMode="auto">
          <a:xfrm>
            <a:off x="1" y="1828800"/>
            <a:ext cx="5029200" cy="5029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0" y="1295400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 Black" pitchFamily="34" charset="0"/>
              </a:rPr>
              <a:t>YTHDF3</a:t>
            </a:r>
            <a:endParaRPr lang="en-GB" dirty="0">
              <a:latin typeface="Arial Black" pitchFamily="34" charset="0"/>
            </a:endParaRPr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856" b="24286"/>
          <a:stretch/>
        </p:blipFill>
        <p:spPr bwMode="auto">
          <a:xfrm>
            <a:off x="4724400" y="1828800"/>
            <a:ext cx="4419600" cy="50659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724400" y="1295400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 Black" pitchFamily="34" charset="0"/>
              </a:rPr>
              <a:t>YTHDC1</a:t>
            </a:r>
            <a:endParaRPr lang="en-GB" dirty="0">
              <a:latin typeface="Arial Black" pitchFamily="34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D0AA03BA-EE0D-1A42-9A43-599862D81591}"/>
              </a:ext>
            </a:extLst>
          </p:cNvPr>
          <p:cNvSpPr/>
          <p:nvPr/>
        </p:nvSpPr>
        <p:spPr>
          <a:xfrm>
            <a:off x="0" y="30081"/>
            <a:ext cx="108012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Figure </a:t>
            </a:r>
            <a:r>
              <a:rPr lang="en-GB" b="1" dirty="0" smtClean="0"/>
              <a:t>S5 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76200" y="609600"/>
            <a:ext cx="5334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 Black" pitchFamily="34" charset="0"/>
              </a:rPr>
              <a:t>A</a:t>
            </a:r>
            <a:endParaRPr lang="en-GB" dirty="0">
              <a:latin typeface="Arial Black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724400" y="609600"/>
            <a:ext cx="5334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 Black" pitchFamily="34" charset="0"/>
              </a:rPr>
              <a:t>B</a:t>
            </a:r>
            <a:endParaRPr lang="en-GB" dirty="0"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26093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685800"/>
            <a:ext cx="4608513" cy="61675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7800" y="685800"/>
            <a:ext cx="3354861" cy="63483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0" y="1295400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 Black" pitchFamily="34" charset="0"/>
              </a:rPr>
              <a:t>YTHDF1</a:t>
            </a:r>
            <a:endParaRPr lang="en-GB" dirty="0">
              <a:latin typeface="Arial Black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486400" y="1295400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 Black" pitchFamily="34" charset="0"/>
              </a:rPr>
              <a:t>YTHDF3</a:t>
            </a:r>
            <a:endParaRPr lang="en-GB" dirty="0">
              <a:latin typeface="Arial Black" pitchFamily="34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D0AA03BA-EE0D-1A42-9A43-599862D81591}"/>
              </a:ext>
            </a:extLst>
          </p:cNvPr>
          <p:cNvSpPr/>
          <p:nvPr/>
        </p:nvSpPr>
        <p:spPr>
          <a:xfrm>
            <a:off x="0" y="30081"/>
            <a:ext cx="108012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Figure </a:t>
            </a:r>
            <a:r>
              <a:rPr lang="en-GB" b="1" dirty="0" smtClean="0"/>
              <a:t>S6 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0" y="609600"/>
            <a:ext cx="5334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 Black" pitchFamily="34" charset="0"/>
              </a:rPr>
              <a:t>A</a:t>
            </a:r>
            <a:endParaRPr lang="en-GB" dirty="0">
              <a:latin typeface="Arial Black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334000" y="609600"/>
            <a:ext cx="5334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 Black" pitchFamily="34" charset="0"/>
              </a:rPr>
              <a:t>B</a:t>
            </a:r>
            <a:endParaRPr lang="en-GB" dirty="0"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412394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09600"/>
            <a:ext cx="4267201" cy="6248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3432" y="609600"/>
            <a:ext cx="4484868" cy="6248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0" y="1295400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 Black" pitchFamily="34" charset="0"/>
              </a:rPr>
              <a:t>YTHDC1</a:t>
            </a:r>
            <a:endParaRPr lang="en-GB" dirty="0">
              <a:latin typeface="Arial Black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876800" y="1295400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 Black" pitchFamily="34" charset="0"/>
              </a:rPr>
              <a:t>YTHDC2</a:t>
            </a:r>
            <a:endParaRPr lang="en-GB" dirty="0">
              <a:latin typeface="Arial Black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xmlns="" id="{D0AA03BA-EE0D-1A42-9A43-599862D81591}"/>
              </a:ext>
            </a:extLst>
          </p:cNvPr>
          <p:cNvSpPr/>
          <p:nvPr/>
        </p:nvSpPr>
        <p:spPr>
          <a:xfrm>
            <a:off x="0" y="30081"/>
            <a:ext cx="108012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Figure </a:t>
            </a:r>
            <a:r>
              <a:rPr lang="en-GB" b="1" dirty="0" smtClean="0"/>
              <a:t>S7 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0" y="609600"/>
            <a:ext cx="5334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 Black" pitchFamily="34" charset="0"/>
              </a:rPr>
              <a:t>A</a:t>
            </a:r>
            <a:endParaRPr lang="en-GB" dirty="0">
              <a:latin typeface="Arial Black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876800" y="609600"/>
            <a:ext cx="5334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 Black" pitchFamily="34" charset="0"/>
              </a:rPr>
              <a:t>B</a:t>
            </a:r>
            <a:endParaRPr lang="en-GB" dirty="0"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366834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0120" y="343139"/>
            <a:ext cx="7398865" cy="648478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="" xmlns:a16="http://schemas.microsoft.com/office/drawing/2014/main" id="{26EF2475-EA33-8245-A787-5F32DF8FD432}"/>
              </a:ext>
            </a:extLst>
          </p:cNvPr>
          <p:cNvSpPr/>
          <p:nvPr/>
        </p:nvSpPr>
        <p:spPr>
          <a:xfrm>
            <a:off x="0" y="30081"/>
            <a:ext cx="108012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Figure </a:t>
            </a:r>
            <a:r>
              <a:rPr lang="en-GB" b="1" dirty="0" smtClean="0"/>
              <a:t>S8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1549757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5</TotalTime>
  <Words>46</Words>
  <Application>Microsoft Office PowerPoint</Application>
  <PresentationFormat>On-screen Show (4:3)</PresentationFormat>
  <Paragraphs>36</Paragraphs>
  <Slides>1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Supplementary figur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novo</dc:creator>
  <cp:lastModifiedBy>lenovo</cp:lastModifiedBy>
  <cp:revision>19</cp:revision>
  <dcterms:created xsi:type="dcterms:W3CDTF">2006-08-16T00:00:00Z</dcterms:created>
  <dcterms:modified xsi:type="dcterms:W3CDTF">2020-05-20T14:37:49Z</dcterms:modified>
</cp:coreProperties>
</file>